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985000" cy="92837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-250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0732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3431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410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7140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1441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8924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037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6400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9493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4065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5134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2283D-F7D1-4E96-8232-2B577460C63D}" type="datetimeFigureOut">
              <a:rPr lang="de-DE" smtClean="0"/>
              <a:t>26.10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46FBD-CB54-4D2F-80ED-BF2ED82C4F1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1162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7458923" y="0"/>
            <a:ext cx="1685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781946" y="269440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3112508" y="238960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2" name="Rechteck 1"/>
          <p:cNvSpPr/>
          <p:nvPr/>
        </p:nvSpPr>
        <p:spPr>
          <a:xfrm>
            <a:off x="191146" y="4931190"/>
            <a:ext cx="8610600" cy="15542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 </a:t>
            </a:r>
            <a:endParaRPr lang="de-DE" dirty="0"/>
          </a:p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Ca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s were co-stimulated with 100 µM histamine and 200 U/ml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terferon-γ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FN-γ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pre-incubated wit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marogent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100 µM) or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zelastin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24 µM) for 30 minutes.  After 24 h IL-8 expression was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sess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the cell supernatant (n=3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y Enzyme-Linked Immunosorbent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sa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ELISA) using a commercial kit from R&amp;D Systems according to the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anufacturer’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structions. 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546" y="1425990"/>
            <a:ext cx="3276600" cy="40060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hteck 2"/>
          <p:cNvSpPr/>
          <p:nvPr/>
        </p:nvSpPr>
        <p:spPr>
          <a:xfrm>
            <a:off x="185979" y="0"/>
            <a:ext cx="733844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marogenti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n histamine and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γ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induced MMP-1 production in 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uman keratinocytes</a:t>
            </a:r>
          </a:p>
          <a:p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istamin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nly slightly enhanced the production of MMP-1, whereas IFN-γ increased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ynergisticall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is expression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marogenti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s well as azelastine could inhibit the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leas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MMP-1 in histamine and IFN-γ co-stimulat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aCa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2731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4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Ute Wölfle</dc:creator>
  <cp:lastModifiedBy>staff</cp:lastModifiedBy>
  <cp:revision>12</cp:revision>
  <cp:lastPrinted>2015-10-26T09:48:20Z</cp:lastPrinted>
  <dcterms:created xsi:type="dcterms:W3CDTF">2015-10-07T09:17:01Z</dcterms:created>
  <dcterms:modified xsi:type="dcterms:W3CDTF">2015-10-26T09:50:14Z</dcterms:modified>
</cp:coreProperties>
</file>